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9"/>
  </p:notesMasterIdLst>
  <p:sldIdLst>
    <p:sldId id="270" r:id="rId2"/>
    <p:sldId id="267" r:id="rId3"/>
    <p:sldId id="266" r:id="rId4"/>
    <p:sldId id="271" r:id="rId5"/>
    <p:sldId id="272" r:id="rId6"/>
    <p:sldId id="273" r:id="rId7"/>
    <p:sldId id="269" r:id="rId8"/>
  </p:sldIdLst>
  <p:sldSz cx="12192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4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65" autoAdjust="0"/>
    <p:restoredTop sz="90960" autoAdjust="0"/>
  </p:normalViewPr>
  <p:slideViewPr>
    <p:cSldViewPr snapToGrid="0">
      <p:cViewPr>
        <p:scale>
          <a:sx n="40" d="100"/>
          <a:sy n="40" d="100"/>
        </p:scale>
        <p:origin x="1608" y="246"/>
      </p:cViewPr>
      <p:guideLst>
        <p:guide orient="horz" pos="283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FB4CCC-4F76-495F-A5BB-918CA9877395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38263" y="1143000"/>
            <a:ext cx="41814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091D87-7676-4717-BC6D-7807E1931FA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81615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091D87-7676-4717-BC6D-7807E1931FA2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85874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091D87-7676-4717-BC6D-7807E1931FA2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4713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091D87-7676-4717-BC6D-7807E1931FA2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001835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091D87-7676-4717-BC6D-7807E1931FA2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012883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091D87-7676-4717-BC6D-7807E1931FA2}" type="slidenum">
              <a:rPr lang="it-IT" smtClean="0"/>
              <a:t>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678662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091D87-7676-4717-BC6D-7807E1931FA2}" type="slidenum">
              <a:rPr lang="it-IT" smtClean="0"/>
              <a:t>6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216023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338263" y="1143000"/>
            <a:ext cx="41814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200000"/>
              </a:lnSpc>
            </a:pP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9091D87-7676-4717-BC6D-7807E1931FA2}" type="slidenum">
              <a:rPr lang="it-IT" smtClean="0"/>
              <a:t>7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932969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72842"/>
            <a:ext cx="1036320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726842"/>
            <a:ext cx="9144000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3027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5737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79142"/>
            <a:ext cx="2628900" cy="7626692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79142"/>
            <a:ext cx="7734300" cy="7626692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0541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4727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43638"/>
            <a:ext cx="10515600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022610"/>
            <a:ext cx="10515600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2640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95710"/>
            <a:ext cx="5181600" cy="571012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95710"/>
            <a:ext cx="5181600" cy="571012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3414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79144"/>
            <a:ext cx="10515600" cy="1739495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06137"/>
            <a:ext cx="5157787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87331"/>
            <a:ext cx="5157787" cy="483516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06137"/>
            <a:ext cx="5183188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87331"/>
            <a:ext cx="5183188" cy="483516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8484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9125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5523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95769"/>
            <a:ext cx="6172200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0070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95769"/>
            <a:ext cx="6172200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6564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79144"/>
            <a:ext cx="1051560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95710"/>
            <a:ext cx="1051560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33F8E0-84FD-41BB-9233-1E1D8515E5A2}" type="datetimeFigureOut">
              <a:rPr lang="it-IT" smtClean="0"/>
              <a:t>26/04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341240"/>
            <a:ext cx="41148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E886D-1C5A-489C-ABFB-4B546B139D4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8725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>
            <a:extLst>
              <a:ext uri="{FF2B5EF4-FFF2-40B4-BE49-F238E27FC236}">
                <a16:creationId xmlns:a16="http://schemas.microsoft.com/office/drawing/2014/main" id="{2B12677D-D9B7-43B6-AA33-98F76DF3A5D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643467" y="155820"/>
            <a:ext cx="10905066" cy="69113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A2B9402B-9098-4FCB-90B9-A917D346A3E6}"/>
              </a:ext>
            </a:extLst>
          </p:cNvPr>
          <p:cNvSpPr txBox="1"/>
          <p:nvPr/>
        </p:nvSpPr>
        <p:spPr>
          <a:xfrm>
            <a:off x="643466" y="7551061"/>
            <a:ext cx="10905065" cy="11159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57200" algn="just">
              <a:lnSpc>
                <a:spcPct val="200000"/>
              </a:lnSpc>
            </a:pPr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1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URB597 scaffold and definition of the three main regions. Region A: aliphatic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N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linked group (left side); region B: proximal phenyl ring (central); region C: distal phenyl rings (right side).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19411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>
            <a:extLst>
              <a:ext uri="{FF2B5EF4-FFF2-40B4-BE49-F238E27FC236}">
                <a16:creationId xmlns:a16="http://schemas.microsoft.com/office/drawing/2014/main" id="{CE3A574C-736D-4551-AD6E-A9A63D2D13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96237" y="375626"/>
            <a:ext cx="6980525" cy="4590686"/>
          </a:xfrm>
          <a:prstGeom prst="rect">
            <a:avLst/>
          </a:prstGeom>
        </p:spPr>
      </p:pic>
      <p:sp>
        <p:nvSpPr>
          <p:cNvPr id="128" name="CasellaDiTesto 127">
            <a:extLst>
              <a:ext uri="{FF2B5EF4-FFF2-40B4-BE49-F238E27FC236}">
                <a16:creationId xmlns:a16="http://schemas.microsoft.com/office/drawing/2014/main" id="{1A2E90A3-077E-4389-97F7-1E858B62C01C}"/>
              </a:ext>
            </a:extLst>
          </p:cNvPr>
          <p:cNvSpPr txBox="1"/>
          <p:nvPr/>
        </p:nvSpPr>
        <p:spPr>
          <a:xfrm>
            <a:off x="590550" y="5480662"/>
            <a:ext cx="10706100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2S. Experimental design. 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wo groups of rats (Group A and B) were treated with NTG or its vehicle and 3 hours later were given one of the FAAH inhibitors (ARN14280 or ARN14633) or vehicle. Rats in Group A underwent the orofacial formalin test one hour later (i.e., 4 hours after NTG/vehicle administration) for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ehavioral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alysis. At the end of the test, the animals were sacrificed to collect medulla, cervical spinal cord and trigeminal ganglion for mRNA expression measurements. This group included a set of animals that received URB597 as FAAH inhibitor before undergoing orofacial formalin test for internal control purposes. In a second experimental group (B), animals were treated with NTG or its vehicle and were given 3 hours later either one of the FAAH inhibitors (ARN14280, ARN14633) or vehicle. One hour later, the animals were sacrificed to collect medulla, cervical spinal cord, and trigeminal ganglion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 quantification of AEA, PEA, OEA and 2-AG.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22584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72B5EF31-E6BE-4691-B9E2-F997475D62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8786" y="968517"/>
            <a:ext cx="6974428" cy="3328704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9F4C1CE0-E77C-4CE3-92C3-CA31458A4B3B}"/>
              </a:ext>
            </a:extLst>
          </p:cNvPr>
          <p:cNvSpPr txBox="1"/>
          <p:nvPr/>
        </p:nvSpPr>
        <p:spPr>
          <a:xfrm>
            <a:off x="1733550" y="4995386"/>
            <a:ext cx="87249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3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ime spent in face rubbing (seconds) during Phase I and II of the orofacial formalin test in the groups of rats treated with NTG vehicle (CT), ARN14663 and ARN14280 (n. 9 per group). Data are reported as mean ± SEM.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ne-way ANOVA followed by Tukey's multiple comparisons test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1511912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8D8F7CB1-019A-4FAC-AC56-D045415BAC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69286" y="1159161"/>
            <a:ext cx="6853428" cy="2490216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FA30B562-D7DF-4DFB-A2D1-018390980528}"/>
              </a:ext>
            </a:extLst>
          </p:cNvPr>
          <p:cNvSpPr txBox="1"/>
          <p:nvPr/>
        </p:nvSpPr>
        <p:spPr>
          <a:xfrm>
            <a:off x="1419225" y="4238191"/>
            <a:ext cx="9353550" cy="22239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4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-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s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mRNA levels (expressed as relative quantification, RQ) in trigeminal ganglion (TG) and cervical spinal cord (CSC) ipsilateral to formalin injection and medulla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toto,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the groups of rats treated with NTG vehicle (CT), ARN14663 and ARN14280 (n = 9 per group)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ata are reported as mean ± SEM;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ne-way ANOVA followed by Tukey's multiple comparisons tes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14675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266EA572-DB8A-4461-BF48-09099B5102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5814" y="905865"/>
            <a:ext cx="7425572" cy="7187807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D6465C6D-F044-4419-9740-76789E89896E}"/>
              </a:ext>
            </a:extLst>
          </p:cNvPr>
          <p:cNvSpPr txBox="1"/>
          <p:nvPr/>
        </p:nvSpPr>
        <p:spPr>
          <a:xfrm>
            <a:off x="7429500" y="2514732"/>
            <a:ext cx="4095750" cy="61019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5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GRP (A), SP (B) and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NOS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C) mRNA levels (expressed as relative quantification, RQ) in trigeminal ganglion (TG) and cervical spinal cord (CSC) ipsilateral to formalin injection and medulla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toto,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the groups of rats treated with NTG vehicle (CT), ARN14663 and ARN14280 (n = 9 per group).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ata are reported as mean ± SEM;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ne-way ANOVA followed by Tukey's multiple comparisons tes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42774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magine 13">
            <a:extLst>
              <a:ext uri="{FF2B5EF4-FFF2-40B4-BE49-F238E27FC236}">
                <a16:creationId xmlns:a16="http://schemas.microsoft.com/office/drawing/2014/main" id="{7F292B07-A86B-4AD0-82B9-379F45A392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1047" y="911962"/>
            <a:ext cx="7364606" cy="7175614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ED633A93-6AB4-4013-BC6F-8B144611E5BE}"/>
              </a:ext>
            </a:extLst>
          </p:cNvPr>
          <p:cNvSpPr txBox="1"/>
          <p:nvPr/>
        </p:nvSpPr>
        <p:spPr>
          <a:xfrm>
            <a:off x="7625653" y="2457582"/>
            <a:ext cx="4019550" cy="61019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6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L-1beta (A), IL-6 (B) and TNF-alpha (C) mRNA levels (expressed as relative quantification, RQ) in trigeminal ganglion (TG) and cervical spinal cord (CSC) ipsilateral to formalin injection and medulla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toto,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the groups of rats treated with NTG vehicle (CT), ARN14663 and ARN14280 (n = 9 per group). Data are reported as mean ± SEM;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ne-way ANOVA followed by Tukey's multiple comparisons tes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46755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magine 7">
            <a:extLst>
              <a:ext uri="{FF2B5EF4-FFF2-40B4-BE49-F238E27FC236}">
                <a16:creationId xmlns:a16="http://schemas.microsoft.com/office/drawing/2014/main" id="{BBAAB1B5-2913-4658-A5DD-7985E230A5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1224" y="236358"/>
            <a:ext cx="9349552" cy="7343537"/>
          </a:xfrm>
          <a:prstGeom prst="rect">
            <a:avLst/>
          </a:prstGeom>
        </p:spPr>
      </p:pic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E4245502-9F5F-4258-98BA-5F9BBC54140F}"/>
              </a:ext>
            </a:extLst>
          </p:cNvPr>
          <p:cNvSpPr txBox="1"/>
          <p:nvPr/>
        </p:nvSpPr>
        <p:spPr>
          <a:xfrm>
            <a:off x="385008" y="7678894"/>
            <a:ext cx="1152525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7S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EA (A, E, I), PEA (B, F, J), OEA (C, G, K) and 2-AG (D, H, L) levels (expressed in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mol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/mg) in cervical spinal cord (CSC), medulla and trigeminal ganglia (TGs) in rats treated with NTG vehicle (CT), ARN14663 and ARN14280 (n. 6 per group). Data are expressed as mean ± SEM;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ukey's multiple comparisons tes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; 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^p&lt;0.05, ^^p&lt;0.01 and ^^^p&lt;0.001 vs CT; #p&lt;0.05 vs ARN14633.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01301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51</TotalTime>
  <Words>657</Words>
  <Application>Microsoft Office PowerPoint</Application>
  <PresentationFormat>Personalizzato</PresentationFormat>
  <Paragraphs>15</Paragraphs>
  <Slides>7</Slides>
  <Notes>7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hiara demartini</dc:creator>
  <cp:lastModifiedBy>chiara demartini</cp:lastModifiedBy>
  <cp:revision>81</cp:revision>
  <dcterms:created xsi:type="dcterms:W3CDTF">2020-03-30T15:19:11Z</dcterms:created>
  <dcterms:modified xsi:type="dcterms:W3CDTF">2022-04-26T10:37:47Z</dcterms:modified>
</cp:coreProperties>
</file>